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99"/>
    <a:srgbClr val="FF66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data.niehs.nih.gov\merrick1\Manuscripts,%202018\AAA%20ACTIVE%20MANUSCRIPTS%20Folder\ARSENIC%20Project_Waalkes%20Merrick%20UDrive\AAA_Data_Figs_Tabl%20Ars%202018%20ACTIVE\Figure%203%20Suppl%20CNV%20qPCR%20exon5%20introns\NIEHS-119%20Appendix%202%20NIEHS_119%20Ct%20Values%202_12-20-201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4555712114933004E-2"/>
          <c:y val="4.658551102725899E-2"/>
          <c:w val="0.90719867384997932"/>
          <c:h val="0.87690669162138501"/>
        </c:manualLayout>
      </c:layout>
      <c:barChart>
        <c:barDir val="col"/>
        <c:grouping val="clustered"/>
        <c:varyColors val="0"/>
        <c:ser>
          <c:idx val="1"/>
          <c:order val="1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DD4D-48FF-8A00-80FC8994FF5A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DD4D-48FF-8A00-80FC8994FF5A}"/>
              </c:ext>
            </c:extLst>
          </c:dPt>
          <c:dPt>
            <c:idx val="2"/>
            <c:invertIfNegative val="0"/>
            <c:bubble3D val="0"/>
            <c:spPr>
              <a:solidFill>
                <a:schemeClr val="accent1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4-DD4D-48FF-8A00-80FC8994FF5A}"/>
              </c:ext>
            </c:extLst>
          </c:dPt>
          <c:dPt>
            <c:idx val="3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DD4D-48FF-8A00-80FC8994FF5A}"/>
              </c:ext>
            </c:extLst>
          </c:dPt>
          <c:dPt>
            <c:idx val="4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6-DD4D-48FF-8A00-80FC8994FF5A}"/>
              </c:ext>
            </c:extLst>
          </c:dPt>
          <c:dPt>
            <c:idx val="5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DD4D-48FF-8A00-80FC8994FF5A}"/>
              </c:ext>
            </c:extLst>
          </c:dPt>
          <c:dPt>
            <c:idx val="9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8-DD4D-48FF-8A00-80FC8994FF5A}"/>
              </c:ext>
            </c:extLst>
          </c:dPt>
          <c:dPt>
            <c:idx val="10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9-DD4D-48FF-8A00-80FC8994FF5A}"/>
              </c:ext>
            </c:extLst>
          </c:dPt>
          <c:dPt>
            <c:idx val="11"/>
            <c:invertIfNegative val="0"/>
            <c:bubble3D val="0"/>
            <c:spPr>
              <a:solidFill>
                <a:schemeClr val="accent2">
                  <a:lumMod val="60000"/>
                  <a:lumOff val="40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A-DD4D-48FF-8A00-80FC8994FF5A}"/>
              </c:ext>
            </c:extLst>
          </c:dPt>
          <c:errBars>
            <c:errBarType val="plus"/>
            <c:errValType val="cust"/>
            <c:noEndCap val="0"/>
            <c:plus>
              <c:numRef>
                <c:f>'Ct Data_FAM'!$M$116:$M$127</c:f>
                <c:numCache>
                  <c:formatCode>General</c:formatCode>
                  <c:ptCount val="12"/>
                  <c:pt idx="0">
                    <c:v>1.2182637919049664</c:v>
                  </c:pt>
                  <c:pt idx="1">
                    <c:v>8.5391256382996619E-2</c:v>
                  </c:pt>
                  <c:pt idx="3">
                    <c:v>6.4549722436790732E-2</c:v>
                  </c:pt>
                  <c:pt idx="4">
                    <c:v>0.17969882210706586</c:v>
                  </c:pt>
                  <c:pt idx="6">
                    <c:v>7.0710678118655043E-2</c:v>
                  </c:pt>
                  <c:pt idx="7">
                    <c:v>0.12909944487358055</c:v>
                  </c:pt>
                  <c:pt idx="9">
                    <c:v>2.4999999999999994E-2</c:v>
                  </c:pt>
                  <c:pt idx="10">
                    <c:v>7.499999999999998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Ct Data_FAM'!$J$116:$J$127</c:f>
              <c:strCache>
                <c:ptCount val="12"/>
                <c:pt idx="0">
                  <c:v>Exon 5_CAsE</c:v>
                </c:pt>
                <c:pt idx="1">
                  <c:v>Exon 5_RWPE</c:v>
                </c:pt>
                <c:pt idx="2">
                  <c:v>Exon 5_NA17223</c:v>
                </c:pt>
                <c:pt idx="3">
                  <c:v>Exon 4_CAsE</c:v>
                </c:pt>
                <c:pt idx="4">
                  <c:v>Exon 4_RWPE</c:v>
                </c:pt>
                <c:pt idx="5">
                  <c:v>Exon 4_NA17223</c:v>
                </c:pt>
                <c:pt idx="6">
                  <c:v>Intron 5_CAsE</c:v>
                </c:pt>
                <c:pt idx="7">
                  <c:v>Intron 5_RWPE</c:v>
                </c:pt>
                <c:pt idx="8">
                  <c:v>Intron 5_NA17223</c:v>
                </c:pt>
                <c:pt idx="9">
                  <c:v>Intron 3_CAsE</c:v>
                </c:pt>
                <c:pt idx="10">
                  <c:v>Intron 3_RWPE</c:v>
                </c:pt>
                <c:pt idx="11">
                  <c:v>Intron 3_NA17223</c:v>
                </c:pt>
              </c:strCache>
            </c:strRef>
          </c:cat>
          <c:val>
            <c:numRef>
              <c:f>'Ct Data_FAM'!$L$116:$L$127</c:f>
              <c:numCache>
                <c:formatCode>General</c:formatCode>
                <c:ptCount val="12"/>
                <c:pt idx="0" formatCode="0.0">
                  <c:v>24.35</c:v>
                </c:pt>
                <c:pt idx="1">
                  <c:v>1.8250000000000002</c:v>
                </c:pt>
                <c:pt idx="2">
                  <c:v>1.85</c:v>
                </c:pt>
                <c:pt idx="3">
                  <c:v>0.74999999999999989</c:v>
                </c:pt>
                <c:pt idx="4">
                  <c:v>2.2749999999999999</c:v>
                </c:pt>
                <c:pt idx="5">
                  <c:v>2.75</c:v>
                </c:pt>
                <c:pt idx="6">
                  <c:v>1</c:v>
                </c:pt>
                <c:pt idx="7">
                  <c:v>2.3000000000000003</c:v>
                </c:pt>
                <c:pt idx="8">
                  <c:v>2.5</c:v>
                </c:pt>
                <c:pt idx="9">
                  <c:v>0.9</c:v>
                </c:pt>
                <c:pt idx="10">
                  <c:v>2.125</c:v>
                </c:pt>
                <c:pt idx="11">
                  <c:v>2.45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D4D-48FF-8A00-80FC8994FF5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0096288"/>
        <c:axId val="550097600"/>
        <c:extLst>
          <c:ext xmlns:c15="http://schemas.microsoft.com/office/drawing/2012/chart" uri="{02D57815-91ED-43cb-92C2-25804820EDAC}">
            <c15:filteredBarSeries>
              <c15:ser>
                <c:idx val="0"/>
                <c:order val="0"/>
                <c:spPr>
                  <a:solidFill>
                    <a:schemeClr val="accent1"/>
                  </a:solidFill>
                  <a:ln>
                    <a:noFill/>
                  </a:ln>
                  <a:effectLst/>
                </c:spPr>
                <c:invertIfNegative val="0"/>
                <c:cat>
                  <c:strRef>
                    <c:extLst>
                      <c:ext uri="{02D57815-91ED-43cb-92C2-25804820EDAC}">
                        <c15:formulaRef>
                          <c15:sqref>'Ct Data_FAM'!$J$116:$J$127</c15:sqref>
                        </c15:formulaRef>
                      </c:ext>
                    </c:extLst>
                    <c:strCache>
                      <c:ptCount val="12"/>
                      <c:pt idx="0">
                        <c:v>Exon 5_CAsE</c:v>
                      </c:pt>
                      <c:pt idx="1">
                        <c:v>Exon 5_RWPE</c:v>
                      </c:pt>
                      <c:pt idx="2">
                        <c:v>Exon 5_NA17223</c:v>
                      </c:pt>
                      <c:pt idx="3">
                        <c:v>Exon 4_CAsE</c:v>
                      </c:pt>
                      <c:pt idx="4">
                        <c:v>Exon 4_RWPE</c:v>
                      </c:pt>
                      <c:pt idx="5">
                        <c:v>Exon 4_NA17223</c:v>
                      </c:pt>
                      <c:pt idx="6">
                        <c:v>Intron 5_CAsE</c:v>
                      </c:pt>
                      <c:pt idx="7">
                        <c:v>Intron 5_RWPE</c:v>
                      </c:pt>
                      <c:pt idx="8">
                        <c:v>Intron 5_NA17223</c:v>
                      </c:pt>
                      <c:pt idx="9">
                        <c:v>Intron 3_CAsE</c:v>
                      </c:pt>
                      <c:pt idx="10">
                        <c:v>Intron 3_RWPE</c:v>
                      </c:pt>
                      <c:pt idx="11">
                        <c:v>Intron 3_NA17223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Ct Data_FAM'!$K$116:$K$127</c15:sqref>
                        </c15:formulaRef>
                      </c:ext>
                    </c:extLst>
                    <c:numCache>
                      <c:formatCode>General</c:formatCode>
                      <c:ptCount val="12"/>
                    </c:numCache>
                  </c:numRef>
                </c:val>
                <c:extLst>
                  <c:ext xmlns:c16="http://schemas.microsoft.com/office/drawing/2014/chart" uri="{C3380CC4-5D6E-409C-BE32-E72D297353CC}">
                    <c16:uniqueId val="{00000001-DD4D-48FF-8A00-80FC8994FF5A}"/>
                  </c:ext>
                </c:extLst>
              </c15:ser>
            </c15:filteredBarSeries>
          </c:ext>
        </c:extLst>
      </c:barChart>
      <c:catAx>
        <c:axId val="550096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0097600"/>
        <c:crosses val="autoZero"/>
        <c:auto val="1"/>
        <c:lblAlgn val="ctr"/>
        <c:lblOffset val="100"/>
        <c:noMultiLvlLbl val="0"/>
      </c:catAx>
      <c:valAx>
        <c:axId val="55009760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0096288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C8E3ED-BF79-4ECE-99EC-0FB6D9B338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52B86A7-BD78-4CC2-A18F-666C885716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EB169E-5926-4519-BFF2-B260B89E1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F57B85-61ED-4B9D-8C2A-F897D09ABB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7071BE-A6F1-4AE4-87C9-92819922B5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56124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29BCEB-97E9-4E6A-B267-F96BBB0D95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FBE0B8-228B-4829-B3DF-E1B328574C5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D5DAE9-799F-472D-85A1-C3897A7CCD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2D433D6-766F-40D6-947B-74646B748B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11E484-6E9A-4E17-9B89-69E47C5AFD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88044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A1B3857-E079-44AD-8A95-96AFB04F02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554896-3A5D-4F1C-80E6-0956A8D176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58ACF14-95FA-46CC-A19B-ED6413F545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C0A3DC-F9F6-4AB1-AA8B-95FA3E5504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5A6078-AC2E-4DF8-976A-26C3F111D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11934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69A6A-14D2-44C7-8C6E-1C1EB2F619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F07675-BD7B-47CA-B595-6632C2C5BE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B1D1BE-B8BC-41D4-B205-0F1B800A3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C4E6D7-396B-4793-A0A2-CC14F886FD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70C5E1-A105-4791-9523-41178B3EA4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12238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D3865D-2589-4073-901B-50FE587E77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2991D06-5ACA-432A-9F94-4D4D81F090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7D7F503-F897-4972-89F9-08F74FA7C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14D230-839C-4298-BE3F-220D492978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08E040-6A1E-46E5-A29B-ECEA875261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33722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3A816F-E2C0-4AAE-92B1-4F3946BFFF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77B5D-5D97-41A4-8C02-4DFFAD1E4C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2BB6C6-E191-4B9F-BEE1-4A185229489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655B851-E55A-4E5A-A16F-A68751622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FCC144-39F1-474D-92D1-87D902DCF7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19C167E-0559-4888-9804-408B377976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78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FEE0B2-8722-410C-BBCC-9D50B25E30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DF4F07E-ED18-4AF4-929C-48A8C1641D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3CF58D8-B322-4C9F-B31F-78046624321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A3EBB30-CD26-4F6D-B94F-9BBB20FFC0D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C0270AA-CDE3-49E6-8A7C-5B2E44C573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696462-A165-4576-A967-6960321B14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2C400EB-AD19-4B5E-B1A7-F0F5B6EBA9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4815720-4987-485B-A55E-B534E4EF8A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2607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04BAB8-FE9E-4BF0-B6E6-EC17D6C577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F3DE68A-2F85-48FD-A29D-D1125B039B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284B79E-F906-4304-AFEA-650C3929F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BF22CD-E045-42F1-917E-539C8DAFA3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9668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78AE6D9-2913-457E-8ACD-1C8C6365B9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572A418-5C15-4D17-AE1E-331532D44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E5FDDA-8F3E-4D80-85D0-64E62D6DAA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691090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B5E5AC-4BA8-4989-95FC-7BAD8307C2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6B15124-85C9-483C-B0BA-F589E3BB91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804F96-D570-4E0B-9F0F-23A69CBD3A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9263B0-D41C-4CEF-B919-E6ABCF0CFA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70257D-BA66-422B-B931-5FC8D9B3B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D89C59-6975-41D4-84A8-8E448BA45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5343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6F9D91-F114-49BA-B15C-443CBA251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46B98C7-53AB-4C79-AEF8-6A609D081B3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F8E31A-CDA4-4F8E-B903-7AC5EF124D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5C850C6-8EF4-4E42-937E-CD000381C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2C11A45-694B-4A43-AC40-0E09BA0FB5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AD9824-FF36-4334-A429-1034933B7F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819933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A2592D1-E427-44CE-A9C6-04552451A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6F55CA-DCB7-4FCC-8AAF-D39EF9DA03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CB99A2-0B68-47C2-AAC4-78810B24A8E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CC2F23-0B63-4C40-9BB4-768E4933C647}" type="datetimeFigureOut">
              <a:rPr lang="en-US" smtClean="0"/>
              <a:t>2/6/2019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8643E8-4C84-4E30-95CE-3516FE9AA3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F6945F-161D-4316-9378-2D8A94D85B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DAF394-7338-4B01-9DBD-3D20927E69F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551874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A96BC072-2BBB-4C8A-A095-F0233E79A5B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13306903"/>
              </p:ext>
            </p:extLst>
          </p:nvPr>
        </p:nvGraphicFramePr>
        <p:xfrm>
          <a:off x="1601640" y="778092"/>
          <a:ext cx="9048750" cy="51763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FDB3D5B2-432C-4CEA-A6A5-1C5940870DE5}"/>
              </a:ext>
            </a:extLst>
          </p:cNvPr>
          <p:cNvSpPr/>
          <p:nvPr/>
        </p:nvSpPr>
        <p:spPr>
          <a:xfrm>
            <a:off x="1994170" y="5626629"/>
            <a:ext cx="8452850" cy="39052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bg1"/>
              </a:solidFill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63F0D65A-FFA0-4F14-87DF-5022350EFF1F}"/>
              </a:ext>
            </a:extLst>
          </p:cNvPr>
          <p:cNvSpPr txBox="1"/>
          <p:nvPr/>
        </p:nvSpPr>
        <p:spPr>
          <a:xfrm rot="16200000">
            <a:off x="2134776" y="5864607"/>
            <a:ext cx="94448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CAsE-PE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1857F73-0709-4A28-A6EF-39DEA8054640}"/>
              </a:ext>
            </a:extLst>
          </p:cNvPr>
          <p:cNvSpPr txBox="1"/>
          <p:nvPr/>
        </p:nvSpPr>
        <p:spPr>
          <a:xfrm rot="16200000">
            <a:off x="2829864" y="5857970"/>
            <a:ext cx="93121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RWPE-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9DB235C-8B7F-46BD-93E0-3C1A4C75D993}"/>
              </a:ext>
            </a:extLst>
          </p:cNvPr>
          <p:cNvSpPr txBox="1"/>
          <p:nvPr/>
        </p:nvSpPr>
        <p:spPr>
          <a:xfrm rot="16200000">
            <a:off x="3307778" y="6032471"/>
            <a:ext cx="128022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Hu Prostate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39A44A4-9551-48F8-B1FC-2599FAFD0EAD}"/>
              </a:ext>
            </a:extLst>
          </p:cNvPr>
          <p:cNvSpPr txBox="1"/>
          <p:nvPr/>
        </p:nvSpPr>
        <p:spPr>
          <a:xfrm rot="16200000">
            <a:off x="4199956" y="5868660"/>
            <a:ext cx="94448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CAsE-PE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0B73710-A9BC-45BD-851A-86191E40922D}"/>
              </a:ext>
            </a:extLst>
          </p:cNvPr>
          <p:cNvSpPr txBox="1"/>
          <p:nvPr/>
        </p:nvSpPr>
        <p:spPr>
          <a:xfrm rot="16200000">
            <a:off x="4895044" y="5862023"/>
            <a:ext cx="93121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RWPE-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3FE4BC7-FD70-4A46-9976-5CCBC0AEF4EE}"/>
              </a:ext>
            </a:extLst>
          </p:cNvPr>
          <p:cNvSpPr txBox="1"/>
          <p:nvPr/>
        </p:nvSpPr>
        <p:spPr>
          <a:xfrm rot="16200000">
            <a:off x="5372958" y="6036524"/>
            <a:ext cx="128022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Hu Prostate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FF689C92-4E14-432D-8CB3-02A3E4CCACB1}"/>
              </a:ext>
            </a:extLst>
          </p:cNvPr>
          <p:cNvSpPr txBox="1"/>
          <p:nvPr/>
        </p:nvSpPr>
        <p:spPr>
          <a:xfrm rot="16200000">
            <a:off x="6265136" y="5863308"/>
            <a:ext cx="94448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CAsE-PE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6CB9C6A7-6256-4E37-9617-6B41CC2EFA05}"/>
              </a:ext>
            </a:extLst>
          </p:cNvPr>
          <p:cNvSpPr txBox="1"/>
          <p:nvPr/>
        </p:nvSpPr>
        <p:spPr>
          <a:xfrm rot="16200000">
            <a:off x="6960224" y="5856671"/>
            <a:ext cx="93121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RWPE-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7950C02-395B-45BC-A8EF-B26A59B67B94}"/>
              </a:ext>
            </a:extLst>
          </p:cNvPr>
          <p:cNvSpPr txBox="1"/>
          <p:nvPr/>
        </p:nvSpPr>
        <p:spPr>
          <a:xfrm rot="16200000">
            <a:off x="7438138" y="6031172"/>
            <a:ext cx="128022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Hu Prostate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1460C2B-DEE4-458A-AAF3-486478A60F4F}"/>
              </a:ext>
            </a:extLst>
          </p:cNvPr>
          <p:cNvSpPr txBox="1"/>
          <p:nvPr/>
        </p:nvSpPr>
        <p:spPr>
          <a:xfrm rot="16200000">
            <a:off x="8330316" y="5867361"/>
            <a:ext cx="944489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CAsE-PE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B0B3C53-557F-4DBF-B051-9E91BD38A29F}"/>
              </a:ext>
            </a:extLst>
          </p:cNvPr>
          <p:cNvSpPr txBox="1"/>
          <p:nvPr/>
        </p:nvSpPr>
        <p:spPr>
          <a:xfrm rot="16200000">
            <a:off x="8998509" y="5860724"/>
            <a:ext cx="931217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RWPE-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3CAA8D4-E7D3-4A43-BB82-5CEEFB8558D5}"/>
              </a:ext>
            </a:extLst>
          </p:cNvPr>
          <p:cNvSpPr txBox="1"/>
          <p:nvPr/>
        </p:nvSpPr>
        <p:spPr>
          <a:xfrm rot="16200000">
            <a:off x="9503318" y="6035225"/>
            <a:ext cx="128022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en-US" dirty="0"/>
              <a:t>Hu Prostat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C0BE711-0325-4216-8600-7A42A75280AD}"/>
              </a:ext>
            </a:extLst>
          </p:cNvPr>
          <p:cNvSpPr txBox="1"/>
          <p:nvPr/>
        </p:nvSpPr>
        <p:spPr>
          <a:xfrm>
            <a:off x="7165437" y="1756577"/>
            <a:ext cx="1216564" cy="17113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/>
              <a:t>Exon 4a</a:t>
            </a:r>
          </a:p>
          <a:p>
            <a:pPr>
              <a:lnSpc>
                <a:spcPct val="150000"/>
              </a:lnSpc>
            </a:pPr>
            <a:r>
              <a:rPr lang="en-US" b="1" dirty="0"/>
              <a:t>Exon 3</a:t>
            </a:r>
          </a:p>
          <a:p>
            <a:pPr>
              <a:lnSpc>
                <a:spcPct val="150000"/>
              </a:lnSpc>
            </a:pPr>
            <a:r>
              <a:rPr lang="en-US" b="1" dirty="0"/>
              <a:t>Intron 5</a:t>
            </a:r>
          </a:p>
          <a:p>
            <a:pPr>
              <a:lnSpc>
                <a:spcPct val="150000"/>
              </a:lnSpc>
            </a:pPr>
            <a:r>
              <a:rPr lang="en-US" b="1" dirty="0"/>
              <a:t>Intron 3</a:t>
            </a:r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FA47D142-9C52-4F51-B3CA-3C993B26E5D5}"/>
              </a:ext>
            </a:extLst>
          </p:cNvPr>
          <p:cNvSpPr/>
          <p:nvPr/>
        </p:nvSpPr>
        <p:spPr>
          <a:xfrm>
            <a:off x="6891626" y="2342424"/>
            <a:ext cx="240632" cy="234618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B7D388DE-CBA2-4DE5-B003-DBB7BB2572D5}"/>
              </a:ext>
            </a:extLst>
          </p:cNvPr>
          <p:cNvSpPr/>
          <p:nvPr/>
        </p:nvSpPr>
        <p:spPr>
          <a:xfrm>
            <a:off x="6891626" y="2754250"/>
            <a:ext cx="240632" cy="234618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132D0CB1-8690-4851-804D-ED6F2B4F6CE0}"/>
              </a:ext>
            </a:extLst>
          </p:cNvPr>
          <p:cNvSpPr/>
          <p:nvPr/>
        </p:nvSpPr>
        <p:spPr>
          <a:xfrm>
            <a:off x="6891626" y="3161397"/>
            <a:ext cx="240632" cy="234618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7A5B38E6-D948-4907-8746-97C4648F6766}"/>
              </a:ext>
            </a:extLst>
          </p:cNvPr>
          <p:cNvSpPr/>
          <p:nvPr/>
        </p:nvSpPr>
        <p:spPr>
          <a:xfrm>
            <a:off x="6891626" y="1928781"/>
            <a:ext cx="240632" cy="234618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10373C4-34A6-4092-A07E-3C7D85C91BD0}"/>
              </a:ext>
            </a:extLst>
          </p:cNvPr>
          <p:cNvSpPr txBox="1"/>
          <p:nvPr/>
        </p:nvSpPr>
        <p:spPr>
          <a:xfrm rot="16200000">
            <a:off x="-327079" y="2758036"/>
            <a:ext cx="310233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dirty="0"/>
              <a:t>Relative Copy Numbe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89831AC-CEFA-41C9-88FB-168424A7A60F}"/>
              </a:ext>
            </a:extLst>
          </p:cNvPr>
          <p:cNvSpPr txBox="1"/>
          <p:nvPr/>
        </p:nvSpPr>
        <p:spPr>
          <a:xfrm>
            <a:off x="1287780" y="182880"/>
            <a:ext cx="96088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/>
              <a:t>S3 Fig. </a:t>
            </a:r>
            <a:r>
              <a:rPr lang="en-US" sz="2400" dirty="0"/>
              <a:t>qPCR Copy Number Analysis for exons 4a and 3, and introns 5 and 3</a:t>
            </a:r>
          </a:p>
          <a:p>
            <a:r>
              <a:rPr lang="en-US" sz="1200" dirty="0"/>
              <a:t>See Methods text for further details on qPCR analysis </a:t>
            </a:r>
            <a:r>
              <a:rPr lang="en-US" sz="1200"/>
              <a:t>and procedures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3859753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1</TotalTime>
  <Words>57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ncy Merrick</dc:creator>
  <cp:lastModifiedBy>Merrick, Alex (NIH/NIEHS) [E]</cp:lastModifiedBy>
  <cp:revision>22</cp:revision>
  <dcterms:created xsi:type="dcterms:W3CDTF">2018-09-02T20:55:52Z</dcterms:created>
  <dcterms:modified xsi:type="dcterms:W3CDTF">2019-02-06T18:12:38Z</dcterms:modified>
</cp:coreProperties>
</file>